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4" r:id="rId2"/>
    <p:sldId id="258" r:id="rId3"/>
    <p:sldId id="261" r:id="rId4"/>
    <p:sldId id="270" r:id="rId5"/>
    <p:sldId id="268" r:id="rId6"/>
    <p:sldId id="269" r:id="rId7"/>
  </p:sldIdLst>
  <p:sldSz cx="9144000" cy="6858000" type="screen4x3"/>
  <p:notesSz cx="6805613" cy="9944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641" autoAdjust="0"/>
    <p:restoredTop sz="97049" autoAdjust="0"/>
  </p:normalViewPr>
  <p:slideViewPr>
    <p:cSldViewPr snapToGrid="0">
      <p:cViewPr varScale="1">
        <p:scale>
          <a:sx n="65" d="100"/>
          <a:sy n="65" d="100"/>
        </p:scale>
        <p:origin x="128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89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89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4A8AAD-8FAD-4810-AE6E-EE336CB64645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3013"/>
            <a:ext cx="447198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85598"/>
            <a:ext cx="5444490" cy="3915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70"/>
            <a:ext cx="2949099" cy="49893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70"/>
            <a:ext cx="2949099" cy="49893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3AB438-A761-42C1-AEC6-219A17F45D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067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3AB438-A761-42C1-AEC6-219A17F45D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7097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58004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65376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43254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7344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20924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33866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1963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69595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0548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97443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04429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F956A-2C1C-4A68-AFB2-94FD855A9743}" type="datetimeFigureOut">
              <a:rPr lang="nl-NL" smtClean="0"/>
              <a:t>17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52690-DC0C-4505-AA87-4A8D2659B4F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24309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81823" y="205737"/>
            <a:ext cx="4083304" cy="2492990"/>
          </a:xfrm>
        </p:spPr>
        <p:txBody>
          <a:bodyPr wrap="square">
            <a:spAutoFit/>
          </a:bodyPr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CATCCAGGAAGTCAGCC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AATGGAGCCAGTAGATCCTAGACTAGAGC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11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9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0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GC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∆2  +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3 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</a:t>
            </a:r>
            <a:r>
              <a:rPr lang="nl-NL" altLang="zh-CN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9  +1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0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altLang="zh-CN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AGTCAGCC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20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3 +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3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C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4957058" y="54845"/>
            <a:ext cx="78098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1 -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3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8643553" y="456976"/>
            <a:ext cx="0" cy="1224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648123" y="1727030"/>
            <a:ext cx="0" cy="77724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8655744" y="857747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55744" y="1971916"/>
            <a:ext cx="3834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ontent Placeholder 2"/>
          <p:cNvSpPr txBox="1">
            <a:spLocks/>
          </p:cNvSpPr>
          <p:nvPr/>
        </p:nvSpPr>
        <p:spPr>
          <a:xfrm>
            <a:off x="4966033" y="2813724"/>
            <a:ext cx="4111121" cy="23907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CAGTAGATCCTAGACTAGAGCCC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CATCCAGGAAGTCAGCC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GCAT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    AATGGAGCCAGTAGATCCTAGAC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CAGTAGATCCTAGACTAGAGCCC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CAGCC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17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9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CAGTAGATCCTAGACTAGAGC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2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7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CAGTAGAT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3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CAGTAGAT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36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0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  +1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4 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8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CTAGAGC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1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3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 +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CAGTAGATCCTAGACTAGAGCCCTGGAAGC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--------------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∆16 +1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GAAGTCAGCC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19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CCCT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0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GGAGCCAGTAGATCCTAGACTAG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1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937628" y="2655895"/>
            <a:ext cx="157924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1 -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6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8643449" y="3143725"/>
            <a:ext cx="0" cy="105156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8642875" y="4224876"/>
            <a:ext cx="0" cy="9144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8638618" y="2973969"/>
            <a:ext cx="329506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altLang="zh-CN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8623127" y="3599646"/>
            <a:ext cx="494222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 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8641792" y="4559250"/>
            <a:ext cx="393006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8642432" y="3046359"/>
            <a:ext cx="0" cy="72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837081" y="666715"/>
            <a:ext cx="27764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798982" y="3002162"/>
            <a:ext cx="277640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</p:txBody>
      </p:sp>
      <p:sp>
        <p:nvSpPr>
          <p:cNvPr id="40" name="Content Placeholder 2"/>
          <p:cNvSpPr txBox="1">
            <a:spLocks/>
          </p:cNvSpPr>
          <p:nvPr/>
        </p:nvSpPr>
        <p:spPr>
          <a:xfrm>
            <a:off x="344908" y="193744"/>
            <a:ext cx="4159917" cy="17739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CTACTAGTACCCTTCAGGAA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CTACTA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CT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</a:t>
            </a:r>
            <a:r>
              <a:rPr lang="nl-NL" sz="600" b="1" dirty="0" smtClean="0">
                <a:solidFill>
                  <a:srgbClr val="FF0000"/>
                </a:solidFill>
                <a:uFill>
                  <a:solidFill>
                    <a:srgbClr val="00B050"/>
                  </a:solidFill>
                </a:u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</a:t>
            </a:r>
            <a:r>
              <a:rPr lang="nl-NL" sz="600" b="1" dirty="0" smtClean="0">
                <a:solidFill>
                  <a:srgbClr val="FF0000"/>
                </a:solidFill>
                <a:uFill>
                  <a:solidFill>
                    <a:srgbClr val="00B050"/>
                  </a:solidFill>
                </a:u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CTAC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   ATGAGAGAACCAAGGGGAAGTGACA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</a:t>
            </a:r>
            <a:r>
              <a:rPr lang="nl-NL" sz="600" dirty="0" smtClean="0">
                <a:uFill>
                  <a:solidFill>
                    <a:schemeClr val="tx1"/>
                  </a:solidFill>
                </a:u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solidFill>
                  <a:srgbClr val="00B0F0"/>
                </a:solidFill>
                <a:uFill>
                  <a:solidFill>
                    <a:schemeClr val="tx1"/>
                  </a:solidFill>
                </a:uFill>
                <a:latin typeface="Courier New" panose="02070309020205020404" pitchFamily="49" charset="0"/>
                <a:cs typeface="Courier New" panose="02070309020205020404" pitchFamily="49" charset="0"/>
              </a:rPr>
              <a:t>C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ACCCTTCAGGAA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∆50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7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7 +2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 +2   ATGAGAGAACC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7 +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346444" y="50353"/>
            <a:ext cx="827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g1 -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3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4062273" y="658397"/>
            <a:ext cx="0" cy="9144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H="1">
            <a:off x="4060205" y="1633015"/>
            <a:ext cx="2" cy="2286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4062489" y="350979"/>
            <a:ext cx="3044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55803" y="464862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bstitution</a:t>
            </a:r>
            <a:endParaRPr 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060002" y="1660029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42983" y="1026708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ontent Placeholder 2"/>
          <p:cNvSpPr txBox="1">
            <a:spLocks/>
          </p:cNvSpPr>
          <p:nvPr/>
        </p:nvSpPr>
        <p:spPr>
          <a:xfrm>
            <a:off x="358834" y="2806087"/>
            <a:ext cx="4169051" cy="2090598"/>
          </a:xfrm>
          <a:prstGeom prst="rect">
            <a:avLst/>
          </a:prstGeom>
          <a:noFill/>
          <a:ln>
            <a:noFill/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CTACTAGTACCCTTCAGGAA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9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0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0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7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</a:t>
            </a:r>
            <a:r>
              <a:rPr lang="nl-NL" altLang="zh-CN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∆4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TGGATGA  ∆47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9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CAT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G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8  +1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CCC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7 +5  ATGAGAGAACCAAGG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AAGT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8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AGAACCAAGGGG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∆40 +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CTTCAGG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ATGGATGA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53 +3</a:t>
            </a:r>
          </a:p>
        </p:txBody>
      </p:sp>
      <p:sp>
        <p:nvSpPr>
          <p:cNvPr id="49" name="Rectangle 48"/>
          <p:cNvSpPr/>
          <p:nvPr/>
        </p:nvSpPr>
        <p:spPr>
          <a:xfrm>
            <a:off x="365126" y="2640014"/>
            <a:ext cx="827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g1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6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4092799" y="3041757"/>
            <a:ext cx="0" cy="105156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4088797" y="4142338"/>
            <a:ext cx="0" cy="59436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4030524" y="3465700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034141" y="4332133"/>
            <a:ext cx="3746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4061135" y="420412"/>
            <a:ext cx="0" cy="72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4061135" y="534712"/>
            <a:ext cx="0" cy="72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Content Placeholder 2"/>
          <p:cNvSpPr txBox="1">
            <a:spLocks/>
          </p:cNvSpPr>
          <p:nvPr/>
        </p:nvSpPr>
        <p:spPr>
          <a:xfrm>
            <a:off x="185821" y="371881"/>
            <a:ext cx="348585" cy="18735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×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 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7" name="Content Placeholder 2"/>
          <p:cNvSpPr txBox="1">
            <a:spLocks/>
          </p:cNvSpPr>
          <p:nvPr/>
        </p:nvSpPr>
        <p:spPr>
          <a:xfrm>
            <a:off x="222916" y="2988400"/>
            <a:ext cx="348585" cy="17331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 flipH="1">
            <a:off x="3206583" y="4573838"/>
            <a:ext cx="41275" cy="4762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3266908" y="4570663"/>
            <a:ext cx="31750" cy="508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Isosceles Triangle 37"/>
          <p:cNvSpPr/>
          <p:nvPr/>
        </p:nvSpPr>
        <p:spPr>
          <a:xfrm>
            <a:off x="2044995" y="338885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9" name="Isosceles Triangle 38"/>
          <p:cNvSpPr/>
          <p:nvPr/>
        </p:nvSpPr>
        <p:spPr>
          <a:xfrm flipH="1" flipV="1">
            <a:off x="1820754" y="167650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0" name="TextBox 59"/>
          <p:cNvSpPr txBox="1"/>
          <p:nvPr/>
        </p:nvSpPr>
        <p:spPr>
          <a:xfrm>
            <a:off x="2835173" y="115842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1" name="Straight Connector 60"/>
          <p:cNvCxnSpPr/>
          <p:nvPr/>
        </p:nvCxnSpPr>
        <p:spPr>
          <a:xfrm flipV="1">
            <a:off x="2091985" y="443365"/>
            <a:ext cx="0" cy="146304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Isosceles Triangle 61"/>
          <p:cNvSpPr/>
          <p:nvPr/>
        </p:nvSpPr>
        <p:spPr>
          <a:xfrm>
            <a:off x="6683671" y="353172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3" name="Isosceles Triangle 62"/>
          <p:cNvSpPr/>
          <p:nvPr/>
        </p:nvSpPr>
        <p:spPr>
          <a:xfrm flipH="1" flipV="1">
            <a:off x="6459430" y="181937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4" name="TextBox 63"/>
          <p:cNvSpPr txBox="1"/>
          <p:nvPr/>
        </p:nvSpPr>
        <p:spPr>
          <a:xfrm>
            <a:off x="7473849" y="130129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5" name="Straight Connector 64"/>
          <p:cNvCxnSpPr/>
          <p:nvPr/>
        </p:nvCxnSpPr>
        <p:spPr>
          <a:xfrm flipV="1">
            <a:off x="6730661" y="452889"/>
            <a:ext cx="0" cy="20574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Isosceles Triangle 65"/>
          <p:cNvSpPr/>
          <p:nvPr/>
        </p:nvSpPr>
        <p:spPr>
          <a:xfrm>
            <a:off x="2064047" y="2958243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7" name="Isosceles Triangle 66"/>
          <p:cNvSpPr/>
          <p:nvPr/>
        </p:nvSpPr>
        <p:spPr>
          <a:xfrm flipH="1" flipV="1">
            <a:off x="1839806" y="2787008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8" name="TextBox 67"/>
          <p:cNvSpPr txBox="1"/>
          <p:nvPr/>
        </p:nvSpPr>
        <p:spPr>
          <a:xfrm>
            <a:off x="2854225" y="2735200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9" name="Straight Connector 68"/>
          <p:cNvCxnSpPr/>
          <p:nvPr/>
        </p:nvCxnSpPr>
        <p:spPr>
          <a:xfrm flipV="1">
            <a:off x="2111037" y="3057960"/>
            <a:ext cx="0" cy="17373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Isosceles Triangle 69"/>
          <p:cNvSpPr/>
          <p:nvPr/>
        </p:nvSpPr>
        <p:spPr>
          <a:xfrm>
            <a:off x="6664622" y="2963005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71" name="Isosceles Triangle 70"/>
          <p:cNvSpPr/>
          <p:nvPr/>
        </p:nvSpPr>
        <p:spPr>
          <a:xfrm flipH="1" flipV="1">
            <a:off x="6440381" y="2791770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72" name="TextBox 71"/>
          <p:cNvSpPr txBox="1"/>
          <p:nvPr/>
        </p:nvSpPr>
        <p:spPr>
          <a:xfrm>
            <a:off x="7454800" y="2739962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73" name="Straight Connector 72"/>
          <p:cNvCxnSpPr/>
          <p:nvPr/>
        </p:nvCxnSpPr>
        <p:spPr>
          <a:xfrm flipV="1">
            <a:off x="6711612" y="3062722"/>
            <a:ext cx="0" cy="20574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03503" y="5183732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192504" y="5516530"/>
            <a:ext cx="8740943" cy="11310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HIV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roviral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DNA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quences in cultures that demonstrated breakthrough HIV replication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Cellular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NA was isolated at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 and 60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s after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fection. Th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rRNA-targete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gion was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CR-amplified, TA-cloned and sequenced. Sequencing reads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ere aligned to th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 HIV sequence.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rRNA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argets are underlined and the PAM is marked in blue. Black triangles mark the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as12a DNA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leavage site. Substitutions and insertions are shown in red, a deletion as -. Sequences were grouped according to their class: substitution, regular deletion or insertion and the new </a:t>
            </a:r>
            <a:r>
              <a:rPr lang="en-US" sz="9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lin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class (see the text).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e marked sequences that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ere detected multiple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imes and listed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size of the actual deletion (∆) and insertion (+).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2139935" y="612768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2139935" y="70484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2876535" y="1255705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2152635" y="304799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2152635" y="3140068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2201545" y="3323971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2384410" y="3505193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/>
          <p:cNvSpPr/>
          <p:nvPr/>
        </p:nvSpPr>
        <p:spPr>
          <a:xfrm>
            <a:off x="3168635" y="396239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6918310" y="720718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7883510" y="1546218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>
            <a:off x="7007210" y="2181218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/>
          <p:cNvSpPr/>
          <p:nvPr/>
        </p:nvSpPr>
        <p:spPr>
          <a:xfrm>
            <a:off x="7375510" y="1177918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/>
          <p:cNvSpPr/>
          <p:nvPr/>
        </p:nvSpPr>
        <p:spPr>
          <a:xfrm>
            <a:off x="6823060" y="1365243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/>
          <p:cNvSpPr/>
          <p:nvPr/>
        </p:nvSpPr>
        <p:spPr>
          <a:xfrm>
            <a:off x="7358047" y="4151305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/>
          <p:cNvSpPr/>
          <p:nvPr/>
        </p:nvSpPr>
        <p:spPr>
          <a:xfrm>
            <a:off x="7454885" y="3879843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/>
          <p:cNvSpPr/>
          <p:nvPr/>
        </p:nvSpPr>
        <p:spPr>
          <a:xfrm>
            <a:off x="7360285" y="3609721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8" name="Rectangle 107"/>
          <p:cNvSpPr/>
          <p:nvPr/>
        </p:nvSpPr>
        <p:spPr>
          <a:xfrm>
            <a:off x="6991335" y="3238493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/>
          <p:cNvSpPr/>
          <p:nvPr/>
        </p:nvSpPr>
        <p:spPr>
          <a:xfrm>
            <a:off x="7454885" y="3514718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133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850542" y="498553"/>
            <a:ext cx="4165122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ACTTGCTATTG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</a:t>
            </a: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TCAGCCTAAAACTGCTTGTACCACTTGC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TT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7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0 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8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1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</a:t>
            </a:r>
            <a:r>
              <a:rPr lang="nl-NL" altLang="zh-CN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4 +1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40 +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847439" y="341405"/>
            <a:ext cx="13019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2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8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3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8549061" y="878553"/>
            <a:ext cx="0" cy="2743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553088" y="750233"/>
            <a:ext cx="0" cy="72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484098" y="936921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504010" y="1431058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515369" y="1893443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8552029" y="1216397"/>
            <a:ext cx="0" cy="6858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8552029" y="1924493"/>
            <a:ext cx="0" cy="144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8514267" y="700222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861371" y="3266707"/>
            <a:ext cx="379209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ACTTGCTATTG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</a:t>
            </a: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ACTTGCTATTG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CACC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7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0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7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 +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7 +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1 +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0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8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3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6 +5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--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5 +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5 +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GTTGCTTT 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1 +1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874813" y="3091472"/>
            <a:ext cx="13019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2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8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6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543686" y="4142226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526500" y="5227774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8583764" y="3669934"/>
            <a:ext cx="0" cy="11887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8580110" y="4890467"/>
            <a:ext cx="0" cy="86868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8579751" y="3539588"/>
            <a:ext cx="0" cy="9144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8560219" y="3495449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665954" y="680879"/>
            <a:ext cx="32412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11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 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734133" y="3546400"/>
            <a:ext cx="370614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  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85594" y="334956"/>
            <a:ext cx="13019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2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3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69532" y="501476"/>
            <a:ext cx="3745268" cy="249299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ACTTGCTATTG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</a:t>
            </a: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     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TT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G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GCCCTGGAAGCATCCAGGAAGTCAGCCTA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C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8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0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GAGTCAG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1 +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A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CTATTG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5 +1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6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1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1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------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58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31" name="Straight Connector 30"/>
          <p:cNvCxnSpPr/>
          <p:nvPr/>
        </p:nvCxnSpPr>
        <p:spPr>
          <a:xfrm>
            <a:off x="4044625" y="844901"/>
            <a:ext cx="0" cy="6858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000175" y="1123798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010212" y="1779832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4047228" y="736901"/>
            <a:ext cx="0" cy="72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991162" y="2507620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4044625" y="1580750"/>
            <a:ext cx="0" cy="59436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044625" y="2230404"/>
            <a:ext cx="0" cy="684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012558" y="691239"/>
            <a:ext cx="3241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70441" y="3274947"/>
            <a:ext cx="3758647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GCTTGTACCACTTGCTATTG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</a:t>
            </a: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AACT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CCACTC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8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4</a:t>
            </a: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T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1 +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T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4 +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4 +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CTTGCTATTG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5 +3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5 +3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30 +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C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8 +1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TTGCT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9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CTGGAAGCATCCAGGAAGTCAGCCT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TTGCTATTG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GTTGCTTT +21</a:t>
            </a:r>
          </a:p>
          <a:p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GCGGTGGTAGCTGAAGAGGCACAGGCTCCGCAG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77151" y="3122484"/>
            <a:ext cx="13019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2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6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12871" y="3971450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007117" y="5076348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4044621" y="3525895"/>
            <a:ext cx="0" cy="123444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044621" y="4806334"/>
            <a:ext cx="0" cy="82296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194177" y="686331"/>
            <a:ext cx="3241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10×</a:t>
            </a: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17580" y="4093110"/>
            <a:ext cx="277640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3" name="Isosceles Triangle 52"/>
          <p:cNvSpPr/>
          <p:nvPr/>
        </p:nvSpPr>
        <p:spPr>
          <a:xfrm>
            <a:off x="2070057" y="654448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4" name="Isosceles Triangle 53"/>
          <p:cNvSpPr/>
          <p:nvPr/>
        </p:nvSpPr>
        <p:spPr>
          <a:xfrm flipH="1" flipV="1">
            <a:off x="1839800" y="483213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5" name="TextBox 54"/>
          <p:cNvSpPr txBox="1"/>
          <p:nvPr/>
        </p:nvSpPr>
        <p:spPr>
          <a:xfrm>
            <a:off x="2854219" y="431405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 flipV="1">
            <a:off x="2111031" y="754165"/>
            <a:ext cx="0" cy="21945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Isosceles Triangle 56"/>
          <p:cNvSpPr/>
          <p:nvPr/>
        </p:nvSpPr>
        <p:spPr>
          <a:xfrm>
            <a:off x="6551574" y="644922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8" name="Isosceles Triangle 57"/>
          <p:cNvSpPr/>
          <p:nvPr/>
        </p:nvSpPr>
        <p:spPr>
          <a:xfrm flipH="1" flipV="1">
            <a:off x="6321317" y="473687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9" name="TextBox 58"/>
          <p:cNvSpPr txBox="1"/>
          <p:nvPr/>
        </p:nvSpPr>
        <p:spPr>
          <a:xfrm>
            <a:off x="7335736" y="421879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 flipV="1">
            <a:off x="6592548" y="726591"/>
            <a:ext cx="0" cy="13716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Isosceles Triangle 60"/>
          <p:cNvSpPr/>
          <p:nvPr/>
        </p:nvSpPr>
        <p:spPr>
          <a:xfrm>
            <a:off x="2070061" y="3421459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2" name="Isosceles Triangle 61"/>
          <p:cNvSpPr/>
          <p:nvPr/>
        </p:nvSpPr>
        <p:spPr>
          <a:xfrm flipH="1" flipV="1">
            <a:off x="1839804" y="3250224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3" name="TextBox 62"/>
          <p:cNvSpPr txBox="1"/>
          <p:nvPr/>
        </p:nvSpPr>
        <p:spPr>
          <a:xfrm>
            <a:off x="2854223" y="3198416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 flipV="1">
            <a:off x="2111035" y="3521176"/>
            <a:ext cx="0" cy="20574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Isosceles Triangle 64"/>
          <p:cNvSpPr/>
          <p:nvPr/>
        </p:nvSpPr>
        <p:spPr>
          <a:xfrm>
            <a:off x="6555083" y="3420206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6" name="Isosceles Triangle 65"/>
          <p:cNvSpPr/>
          <p:nvPr/>
        </p:nvSpPr>
        <p:spPr>
          <a:xfrm flipH="1" flipV="1">
            <a:off x="6330842" y="3254987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7" name="TextBox 66"/>
          <p:cNvSpPr txBox="1"/>
          <p:nvPr/>
        </p:nvSpPr>
        <p:spPr>
          <a:xfrm>
            <a:off x="7345261" y="3203179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8" name="Straight Connector 67"/>
          <p:cNvCxnSpPr/>
          <p:nvPr/>
        </p:nvCxnSpPr>
        <p:spPr>
          <a:xfrm flipV="1">
            <a:off x="6608089" y="3507891"/>
            <a:ext cx="0" cy="22860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366965" y="6328611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ight Brace 69"/>
          <p:cNvSpPr/>
          <p:nvPr/>
        </p:nvSpPr>
        <p:spPr>
          <a:xfrm rot="16200000">
            <a:off x="1731557" y="5646698"/>
            <a:ext cx="36000" cy="9144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75" name="Rectangle 74"/>
          <p:cNvSpPr/>
          <p:nvPr/>
        </p:nvSpPr>
        <p:spPr>
          <a:xfrm>
            <a:off x="2300272" y="1563681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2486011" y="1749418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2624122" y="1839905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3128947" y="2116130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6734160" y="1292217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6738923" y="1468429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7056425" y="1382705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2670161" y="4063991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2486010" y="3697281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3038460" y="4521191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/>
          <p:cNvSpPr/>
          <p:nvPr/>
        </p:nvSpPr>
        <p:spPr>
          <a:xfrm>
            <a:off x="6743686" y="3787768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/>
          <p:cNvSpPr/>
          <p:nvPr/>
        </p:nvSpPr>
        <p:spPr>
          <a:xfrm>
            <a:off x="6791312" y="3692517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>
            <a:off x="7486634" y="4425943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0494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8432" y="793112"/>
            <a:ext cx="3764172" cy="16619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ACTCATCAAGTTTCTCTA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</a:t>
            </a: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T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CCTCCTCAAGGCAGTCAGA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GCGACGAAGACCTCCTCA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4 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7 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0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G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------------------------------------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5 +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9 +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04308" y="623398"/>
            <a:ext cx="14334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Rev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nl-NL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1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3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3966238" y="1131273"/>
            <a:ext cx="0" cy="13716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926703" y="1083063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929177" y="1441269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3969623" y="1022644"/>
            <a:ext cx="0" cy="720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921673" y="2025664"/>
            <a:ext cx="3883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3971099" y="1311780"/>
            <a:ext cx="0" cy="5029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975532" y="1870021"/>
            <a:ext cx="0" cy="5029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937460" y="935666"/>
            <a:ext cx="303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00791" y="2834788"/>
            <a:ext cx="3756859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ACTCATCAAGTTTCTCTA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</a:t>
            </a: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A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0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9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6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9 +4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+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ACCT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CAGTT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8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A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----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19422" y="2667090"/>
            <a:ext cx="14334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Rev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1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day6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889537" y="3300239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894617" y="4320644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3937836" y="3085852"/>
            <a:ext cx="0" cy="86868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938940" y="4003197"/>
            <a:ext cx="0" cy="9601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43824" y="979798"/>
            <a:ext cx="3706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× 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161205" y="3470669"/>
            <a:ext cx="277640" cy="15696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×</a:t>
            </a: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702190" y="701781"/>
            <a:ext cx="3764172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ACTCATCAAGTTTCTCTA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</a:t>
            </a: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T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TC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TTCTC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4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TT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3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7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9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10 +4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 +1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30 +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31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9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9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717723" y="485777"/>
            <a:ext cx="14334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Rev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2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y3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8383082" y="1047775"/>
            <a:ext cx="0" cy="457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315599" y="981403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313378" y="1368631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8378211" y="939146"/>
            <a:ext cx="0" cy="54864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8323177" y="2029921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8379687" y="1132994"/>
            <a:ext cx="0" cy="6858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8382787" y="1860682"/>
            <a:ext cx="0" cy="50292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8308068" y="850772"/>
            <a:ext cx="303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702191" y="2853418"/>
            <a:ext cx="3817922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ACTCATCAAGTTTCTCTA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</a:t>
            </a:r>
          </a:p>
          <a:p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0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4 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TTCTCTG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0 +5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AAAGACCTCCTCA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 +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3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 +2  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30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31 +2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AT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9 +4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5 +3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8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50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50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ACGAAGACCTCCTCAAGGCAG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CAAGTTTCTCTA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TAAGTAGT +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AG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696094" y="2649875"/>
            <a:ext cx="1462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tRev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8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2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day60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 flipH="1">
            <a:off x="8383057" y="3111036"/>
            <a:ext cx="0" cy="68580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8383057" y="3827035"/>
            <a:ext cx="0" cy="123444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8325904" y="3338090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da-DK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321900" y="4342283"/>
            <a:ext cx="3626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da-DK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4578131" y="3317686"/>
            <a:ext cx="277640" cy="15696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4524657" y="890396"/>
            <a:ext cx="32412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0×</a:t>
            </a: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3×</a:t>
            </a:r>
          </a:p>
        </p:txBody>
      </p:sp>
      <p:sp>
        <p:nvSpPr>
          <p:cNvPr id="47" name="Isosceles Triangle 46"/>
          <p:cNvSpPr/>
          <p:nvPr/>
        </p:nvSpPr>
        <p:spPr>
          <a:xfrm>
            <a:off x="6399175" y="851214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8" name="Isosceles Triangle 47"/>
          <p:cNvSpPr/>
          <p:nvPr/>
        </p:nvSpPr>
        <p:spPr>
          <a:xfrm flipH="1" flipV="1">
            <a:off x="6174934" y="679979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9" name="TextBox 48"/>
          <p:cNvSpPr txBox="1"/>
          <p:nvPr/>
        </p:nvSpPr>
        <p:spPr>
          <a:xfrm>
            <a:off x="7189353" y="628171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6446165" y="950931"/>
            <a:ext cx="0" cy="146304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Isosceles Triangle 50"/>
          <p:cNvSpPr/>
          <p:nvPr/>
        </p:nvSpPr>
        <p:spPr>
          <a:xfrm>
            <a:off x="6405191" y="3003864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2" name="Isosceles Triangle 51"/>
          <p:cNvSpPr/>
          <p:nvPr/>
        </p:nvSpPr>
        <p:spPr>
          <a:xfrm flipH="1" flipV="1">
            <a:off x="6174934" y="2832629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3" name="TextBox 52"/>
          <p:cNvSpPr txBox="1"/>
          <p:nvPr/>
        </p:nvSpPr>
        <p:spPr>
          <a:xfrm>
            <a:off x="7189353" y="2780821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 flipV="1">
            <a:off x="6446165" y="3103581"/>
            <a:ext cx="0" cy="20116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Isosceles Triangle 54"/>
          <p:cNvSpPr/>
          <p:nvPr/>
        </p:nvSpPr>
        <p:spPr>
          <a:xfrm>
            <a:off x="2014167" y="932176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6" name="Isosceles Triangle 55"/>
          <p:cNvSpPr/>
          <p:nvPr/>
        </p:nvSpPr>
        <p:spPr>
          <a:xfrm flipH="1" flipV="1">
            <a:off x="1783910" y="760941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7" name="TextBox 56"/>
          <p:cNvSpPr txBox="1"/>
          <p:nvPr/>
        </p:nvSpPr>
        <p:spPr>
          <a:xfrm>
            <a:off x="2798329" y="709133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 flipV="1">
            <a:off x="2055141" y="1031893"/>
            <a:ext cx="0" cy="13716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Isosceles Triangle 58"/>
          <p:cNvSpPr/>
          <p:nvPr/>
        </p:nvSpPr>
        <p:spPr>
          <a:xfrm>
            <a:off x="2004642" y="2989576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0" name="Isosceles Triangle 59"/>
          <p:cNvSpPr/>
          <p:nvPr/>
        </p:nvSpPr>
        <p:spPr>
          <a:xfrm flipH="1" flipV="1">
            <a:off x="1774385" y="2818341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1" name="TextBox 60"/>
          <p:cNvSpPr txBox="1"/>
          <p:nvPr/>
        </p:nvSpPr>
        <p:spPr>
          <a:xfrm>
            <a:off x="2788804" y="2766533"/>
            <a:ext cx="4083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 flipV="1">
            <a:off x="2045616" y="3089293"/>
            <a:ext cx="0" cy="192024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319839" y="6252411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ight Brace 63"/>
          <p:cNvSpPr/>
          <p:nvPr/>
        </p:nvSpPr>
        <p:spPr>
          <a:xfrm rot="16200000">
            <a:off x="6062926" y="5045119"/>
            <a:ext cx="36000" cy="9144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6" name="Rectangle 65"/>
          <p:cNvSpPr/>
          <p:nvPr/>
        </p:nvSpPr>
        <p:spPr>
          <a:xfrm>
            <a:off x="2093899" y="3259130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2285985" y="1396993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2700321" y="1587492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3289284" y="372109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2424098" y="1497005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2365360" y="3540118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2285985" y="1768468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2281223" y="3444867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6770672" y="1220780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6499210" y="3097206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7694597" y="374014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6765910" y="328294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6681773" y="1587492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3100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jdelijke aanduiding voor inhoud 2"/>
          <p:cNvSpPr>
            <a:spLocks noGrp="1"/>
          </p:cNvSpPr>
          <p:nvPr/>
        </p:nvSpPr>
        <p:spPr>
          <a:xfrm>
            <a:off x="753355" y="563718"/>
            <a:ext cx="2670883" cy="15953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AT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AAAAGAGACCATCAAT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TCAATGAGGAAGCTGCAGAATGGGAT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TC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GAGGAAGCTGCAGAATGGGATA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ATGTTAA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ACCATCAATGAGGAAGCTGCAGAATGGGAT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AGACCATC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TC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TC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T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AATGTTA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AATGGGAT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AATGTTAAAAGAGACCATCAATGAGGAAGCTGCAGAATGGGATA 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2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GG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" name="TextBox 1"/>
          <p:cNvSpPr txBox="1"/>
          <p:nvPr/>
        </p:nvSpPr>
        <p:spPr>
          <a:xfrm>
            <a:off x="753353" y="58255"/>
            <a:ext cx="187709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gGag1+gEnv2 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day12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Gag1 target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/>
          <p:cNvCxnSpPr/>
          <p:nvPr/>
        </p:nvCxnSpPr>
        <p:spPr>
          <a:xfrm>
            <a:off x="3355007" y="916405"/>
            <a:ext cx="0" cy="10800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Right Brace 9"/>
          <p:cNvSpPr/>
          <p:nvPr/>
        </p:nvSpPr>
        <p:spPr>
          <a:xfrm rot="16200000">
            <a:off x="1840366" y="2022577"/>
            <a:ext cx="36000" cy="10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600"/>
          </a:p>
        </p:txBody>
      </p:sp>
      <p:cxnSp>
        <p:nvCxnSpPr>
          <p:cNvPr id="11" name="Straight Connector 10"/>
          <p:cNvCxnSpPr/>
          <p:nvPr/>
        </p:nvCxnSpPr>
        <p:spPr>
          <a:xfrm>
            <a:off x="3355013" y="1081223"/>
            <a:ext cx="0" cy="86868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355004" y="802652"/>
            <a:ext cx="0" cy="54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3313729" y="748860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3313730" y="854573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319085" y="1320148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298031" y="1939961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>
            <a:off x="3354998" y="2002171"/>
            <a:ext cx="0" cy="54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4"/>
          <p:cNvSpPr txBox="1"/>
          <p:nvPr/>
        </p:nvSpPr>
        <p:spPr>
          <a:xfrm>
            <a:off x="814843" y="2418965"/>
            <a:ext cx="149908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Env2 - day12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Env2 target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832424" y="2981982"/>
            <a:ext cx="2677260" cy="221599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TG</a:t>
            </a:r>
            <a:r>
              <a:rPr lang="en-US" sz="600" b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GGAGCAGCAGGAAGCACTAT</a:t>
            </a:r>
            <a:r>
              <a:rPr lang="en-US" sz="6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GCAGCGTCAAT 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GGGCGCAGCGTCAAT       </a:t>
            </a: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GGGCGCAGCGTCAA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AGCGTCAA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GCAGCGTCAA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9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GCGCAGCGTCAA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   </a:t>
            </a: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TGGGCGCAGCGTCAA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+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GCAGCGTCAAT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 +7    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5 +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TGGGCGCAGCGTCAAT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</a:t>
            </a: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ACTATGGGCGCAGCGTCAAT </a:t>
            </a:r>
          </a:p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C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AGC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3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TGGGCGCAGCGTCAAT</a:t>
            </a:r>
          </a:p>
          <a:p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C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2 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CC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3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CCCCC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5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ACT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CGCAGCGTCAAT</a:t>
            </a:r>
          </a:p>
          <a:p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GGGGGT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" name="Right Brace 19"/>
          <p:cNvSpPr/>
          <p:nvPr/>
        </p:nvSpPr>
        <p:spPr>
          <a:xfrm rot="16200000">
            <a:off x="1781141" y="4080695"/>
            <a:ext cx="36000" cy="10800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600"/>
          </a:p>
        </p:txBody>
      </p:sp>
      <p:sp>
        <p:nvSpPr>
          <p:cNvPr id="21" name="Right Brace 20"/>
          <p:cNvSpPr/>
          <p:nvPr/>
        </p:nvSpPr>
        <p:spPr>
          <a:xfrm rot="16200000">
            <a:off x="1780381" y="4239603"/>
            <a:ext cx="45719" cy="18288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600"/>
          </a:p>
        </p:txBody>
      </p:sp>
      <p:sp>
        <p:nvSpPr>
          <p:cNvPr id="28" name="Right Brace 27"/>
          <p:cNvSpPr/>
          <p:nvPr/>
        </p:nvSpPr>
        <p:spPr>
          <a:xfrm rot="16200000">
            <a:off x="1778936" y="4599825"/>
            <a:ext cx="45719" cy="18000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600"/>
          </a:p>
        </p:txBody>
      </p:sp>
      <p:sp>
        <p:nvSpPr>
          <p:cNvPr id="29" name="Right Brace 28"/>
          <p:cNvSpPr/>
          <p:nvPr/>
        </p:nvSpPr>
        <p:spPr>
          <a:xfrm rot="16200000">
            <a:off x="1781225" y="4775524"/>
            <a:ext cx="36000" cy="54000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600"/>
          </a:p>
        </p:txBody>
      </p:sp>
      <p:sp>
        <p:nvSpPr>
          <p:cNvPr id="33" name="TextBox 32"/>
          <p:cNvSpPr txBox="1"/>
          <p:nvPr/>
        </p:nvSpPr>
        <p:spPr>
          <a:xfrm>
            <a:off x="1900130" y="496078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34" name="Isosceles Triangle 33"/>
          <p:cNvSpPr/>
          <p:nvPr/>
        </p:nvSpPr>
        <p:spPr>
          <a:xfrm flipH="1" flipV="1">
            <a:off x="1809568" y="542251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35" name="Straight Connector 34"/>
          <p:cNvCxnSpPr/>
          <p:nvPr/>
        </p:nvCxnSpPr>
        <p:spPr>
          <a:xfrm flipV="1">
            <a:off x="1858240" y="782642"/>
            <a:ext cx="0" cy="12801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600521" y="746466"/>
            <a:ext cx="288479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× </a:t>
            </a:r>
            <a:endParaRPr lang="en-US" sz="1400" dirty="0"/>
          </a:p>
        </p:txBody>
      </p:sp>
      <p:sp>
        <p:nvSpPr>
          <p:cNvPr id="37" name="Rectangle 36"/>
          <p:cNvSpPr/>
          <p:nvPr/>
        </p:nvSpPr>
        <p:spPr>
          <a:xfrm>
            <a:off x="684658" y="3167690"/>
            <a:ext cx="28847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14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3096246" y="3233649"/>
            <a:ext cx="0" cy="13716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3096252" y="3407991"/>
            <a:ext cx="0" cy="32004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>
            <a:off x="3054969" y="3212298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3060324" y="3439746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3039270" y="4469136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3096236" y="3774106"/>
            <a:ext cx="0" cy="2286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096236" y="4045567"/>
            <a:ext cx="0" cy="105156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Rectangle 46"/>
          <p:cNvSpPr/>
          <p:nvPr/>
        </p:nvSpPr>
        <p:spPr>
          <a:xfrm>
            <a:off x="3055561" y="3775503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890607" y="2902220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49" name="Isosceles Triangle 48"/>
          <p:cNvSpPr/>
          <p:nvPr/>
        </p:nvSpPr>
        <p:spPr>
          <a:xfrm flipH="1" flipV="1">
            <a:off x="1800045" y="2948393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1848717" y="3188784"/>
            <a:ext cx="0" cy="91440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ijdelijke aanduiding voor inhoud 2"/>
          <p:cNvSpPr>
            <a:spLocks noGrp="1"/>
          </p:cNvSpPr>
          <p:nvPr/>
        </p:nvSpPr>
        <p:spPr>
          <a:xfrm>
            <a:off x="4382515" y="515833"/>
            <a:ext cx="2947205" cy="18368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AAAAGAGACCATCAAT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TAAAAGAGACCATCAATGAGGAAGCTGCAGAATGGGATA  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TAAAAGAGACCATC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GAAGCTGCAGAATGGGAT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TAAAAGAGACCATC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TTAAAAGAGACCAT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TTAAAA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5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TT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GG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 +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TTAAAAGAGACC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+1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TTAAAAGAGACC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6 +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TTAAAAGAGACCATCAATGAGGAAGCTGCAGAATGGGATA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AC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CACC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8 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AGTAGGAACAAT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+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2" name="TextBox 1"/>
          <p:cNvSpPr txBox="1"/>
          <p:nvPr/>
        </p:nvSpPr>
        <p:spPr>
          <a:xfrm>
            <a:off x="4333869" y="19161"/>
            <a:ext cx="163060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TatRev - day12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l-NL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Gag1 target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ight Brace 52"/>
          <p:cNvSpPr/>
          <p:nvPr/>
        </p:nvSpPr>
        <p:spPr>
          <a:xfrm rot="16200000">
            <a:off x="5607538" y="1762347"/>
            <a:ext cx="36000" cy="16668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350"/>
          </a:p>
        </p:txBody>
      </p:sp>
      <p:sp>
        <p:nvSpPr>
          <p:cNvPr id="64" name="Tijdelijke aanduiding voor inhoud 2"/>
          <p:cNvSpPr txBox="1">
            <a:spLocks/>
          </p:cNvSpPr>
          <p:nvPr/>
        </p:nvSpPr>
        <p:spPr>
          <a:xfrm>
            <a:off x="4382515" y="2889038"/>
            <a:ext cx="2839255" cy="240126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CAGGAAGAAGCGGAG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TATGGCAGGAAGAAGCGGAGACAGCG 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TAT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      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CAGGAAGAAG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TAT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 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9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48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T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AAG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  +1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C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AAGAAG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8  +5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4  +1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0 +6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AGACAG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3 +4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TATGGCAGGAAGAAGCGGAGACAGC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G                      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+1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C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+2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T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+2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A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+2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GTCC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+5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TAGGCATCTCCTAT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TTCTTCAC                  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8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5" name="TextBox 21"/>
          <p:cNvSpPr txBox="1"/>
          <p:nvPr/>
        </p:nvSpPr>
        <p:spPr>
          <a:xfrm>
            <a:off x="4382515" y="2442498"/>
            <a:ext cx="168909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TatRev - day12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l-NL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TatRev </a:t>
            </a:r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target 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ight Brace 65"/>
          <p:cNvSpPr/>
          <p:nvPr/>
        </p:nvSpPr>
        <p:spPr>
          <a:xfrm rot="16200000">
            <a:off x="5288716" y="4443476"/>
            <a:ext cx="34289" cy="10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350"/>
          </a:p>
        </p:txBody>
      </p:sp>
      <p:sp>
        <p:nvSpPr>
          <p:cNvPr id="67" name="Right Brace 66"/>
          <p:cNvSpPr/>
          <p:nvPr/>
        </p:nvSpPr>
        <p:spPr>
          <a:xfrm rot="16200000">
            <a:off x="5285766" y="4910116"/>
            <a:ext cx="34289" cy="432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350"/>
          </a:p>
        </p:txBody>
      </p:sp>
      <p:sp>
        <p:nvSpPr>
          <p:cNvPr id="79" name="Rectangle 78"/>
          <p:cNvSpPr/>
          <p:nvPr/>
        </p:nvSpPr>
        <p:spPr>
          <a:xfrm>
            <a:off x="4224031" y="706360"/>
            <a:ext cx="288479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× </a:t>
            </a:r>
            <a:endParaRPr lang="en-US" sz="1400" dirty="0"/>
          </a:p>
        </p:txBody>
      </p:sp>
      <p:sp>
        <p:nvSpPr>
          <p:cNvPr id="80" name="TextBox 79"/>
          <p:cNvSpPr txBox="1"/>
          <p:nvPr/>
        </p:nvSpPr>
        <p:spPr>
          <a:xfrm>
            <a:off x="5343502" y="450625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81" name="Isosceles Triangle 80"/>
          <p:cNvSpPr/>
          <p:nvPr/>
        </p:nvSpPr>
        <p:spPr>
          <a:xfrm flipH="1" flipV="1">
            <a:off x="5252940" y="496798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82" name="Straight Connector 81"/>
          <p:cNvCxnSpPr/>
          <p:nvPr/>
        </p:nvCxnSpPr>
        <p:spPr>
          <a:xfrm flipV="1">
            <a:off x="5301612" y="737189"/>
            <a:ext cx="0" cy="10972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4935598" y="2905856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84" name="Isosceles Triangle 83"/>
          <p:cNvSpPr/>
          <p:nvPr/>
        </p:nvSpPr>
        <p:spPr>
          <a:xfrm flipH="1" flipV="1">
            <a:off x="5259374" y="2961554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85" name="Straight Connector 84"/>
          <p:cNvCxnSpPr/>
          <p:nvPr/>
        </p:nvCxnSpPr>
        <p:spPr>
          <a:xfrm flipV="1">
            <a:off x="5305665" y="3201945"/>
            <a:ext cx="0" cy="12801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tangle 85"/>
          <p:cNvSpPr/>
          <p:nvPr/>
        </p:nvSpPr>
        <p:spPr>
          <a:xfrm>
            <a:off x="4247843" y="3162509"/>
            <a:ext cx="28847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7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1400" dirty="0"/>
          </a:p>
        </p:txBody>
      </p:sp>
      <p:cxnSp>
        <p:nvCxnSpPr>
          <p:cNvPr id="88" name="Straight Connector 87"/>
          <p:cNvCxnSpPr/>
          <p:nvPr/>
        </p:nvCxnSpPr>
        <p:spPr>
          <a:xfrm>
            <a:off x="6712571" y="3309849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6712577" y="3404816"/>
            <a:ext cx="0" cy="5029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0" name="Rectangle 89"/>
          <p:cNvSpPr/>
          <p:nvPr/>
        </p:nvSpPr>
        <p:spPr>
          <a:xfrm>
            <a:off x="6671294" y="3247223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/>
          <p:cNvSpPr/>
          <p:nvPr/>
        </p:nvSpPr>
        <p:spPr>
          <a:xfrm>
            <a:off x="6676649" y="3560396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6655595" y="4786636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/>
          <p:cNvCxnSpPr/>
          <p:nvPr/>
        </p:nvCxnSpPr>
        <p:spPr>
          <a:xfrm>
            <a:off x="6712561" y="3951906"/>
            <a:ext cx="0" cy="41148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6712561" y="4423392"/>
            <a:ext cx="0" cy="77724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5" name="Rectangle 94"/>
          <p:cNvSpPr/>
          <p:nvPr/>
        </p:nvSpPr>
        <p:spPr>
          <a:xfrm>
            <a:off x="6671886" y="4061253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6712571" y="3220949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6671294" y="3158323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Straight Connector 97"/>
          <p:cNvCxnSpPr/>
          <p:nvPr/>
        </p:nvCxnSpPr>
        <p:spPr>
          <a:xfrm>
            <a:off x="6769724" y="856081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6769730" y="951048"/>
            <a:ext cx="0" cy="5029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0" name="Rectangle 99"/>
          <p:cNvSpPr/>
          <p:nvPr/>
        </p:nvSpPr>
        <p:spPr>
          <a:xfrm>
            <a:off x="6728447" y="793455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100"/>
          <p:cNvSpPr/>
          <p:nvPr/>
        </p:nvSpPr>
        <p:spPr>
          <a:xfrm>
            <a:off x="6733802" y="1106628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6712748" y="1851851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02"/>
          <p:cNvCxnSpPr/>
          <p:nvPr/>
        </p:nvCxnSpPr>
        <p:spPr>
          <a:xfrm>
            <a:off x="6769714" y="1498138"/>
            <a:ext cx="0" cy="2286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6769714" y="1783884"/>
            <a:ext cx="0" cy="32004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5" name="Rectangle 104"/>
          <p:cNvSpPr/>
          <p:nvPr/>
        </p:nvSpPr>
        <p:spPr>
          <a:xfrm>
            <a:off x="6729039" y="1607485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Straight Connector 105"/>
          <p:cNvCxnSpPr/>
          <p:nvPr/>
        </p:nvCxnSpPr>
        <p:spPr>
          <a:xfrm>
            <a:off x="6769724" y="767181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6728447" y="704555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107"/>
          <p:cNvSpPr/>
          <p:nvPr/>
        </p:nvSpPr>
        <p:spPr>
          <a:xfrm>
            <a:off x="5898343" y="1122467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/>
          <p:cNvSpPr/>
          <p:nvPr/>
        </p:nvSpPr>
        <p:spPr>
          <a:xfrm>
            <a:off x="2134379" y="1718574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/>
          <p:cNvSpPr/>
          <p:nvPr/>
        </p:nvSpPr>
        <p:spPr>
          <a:xfrm>
            <a:off x="2127235" y="1813033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/>
          <p:cNvSpPr/>
          <p:nvPr/>
        </p:nvSpPr>
        <p:spPr>
          <a:xfrm>
            <a:off x="2165336" y="3404787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/>
          <p:cNvSpPr/>
          <p:nvPr/>
        </p:nvSpPr>
        <p:spPr>
          <a:xfrm>
            <a:off x="2072466" y="3497654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/>
          <p:cNvSpPr/>
          <p:nvPr/>
        </p:nvSpPr>
        <p:spPr>
          <a:xfrm>
            <a:off x="1931973" y="3585763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/>
          <p:cNvSpPr/>
          <p:nvPr/>
        </p:nvSpPr>
        <p:spPr>
          <a:xfrm>
            <a:off x="5260960" y="3500038"/>
            <a:ext cx="18288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TextBox 114"/>
          <p:cNvSpPr txBox="1"/>
          <p:nvPr/>
        </p:nvSpPr>
        <p:spPr>
          <a:xfrm>
            <a:off x="192504" y="5177737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192504" y="5516530"/>
            <a:ext cx="8740943" cy="11310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HIV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roviral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DNA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quences in gRNA-protected cultures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Cellular DNA was isolated at 12 and 110 days after HIV-1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nfection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he gRNA-targete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gion was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CR-amplified, TA-cloned and sequenced. Sequencing reads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ere aligned to th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 HIV sequence.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rRNA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argets are underlined and the PAM is marked in blue. Black triangles mark the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as9 DNA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leavage site. Substitutions and insertions are shown in red, a deletion as -. Sequences were grouped according to their class: substitution, regular deletion or insertion and the new </a:t>
            </a:r>
            <a:r>
              <a:rPr lang="en-US" sz="9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lin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class (see the text).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e marked sequences that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ere detected multiple </a:t>
            </a:r>
            <a:r>
              <a:rPr lang="en-US" sz="9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imes and listed </a:t>
            </a:r>
            <a:r>
              <a:rPr lang="en-US" sz="9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size of the actual deletion (∆) and insertion (+).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77674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ijdelijke aanduiding voor inhoud 2"/>
          <p:cNvSpPr txBox="1">
            <a:spLocks/>
          </p:cNvSpPr>
          <p:nvPr/>
        </p:nvSpPr>
        <p:spPr>
          <a:xfrm>
            <a:off x="865840" y="656080"/>
            <a:ext cx="2725085" cy="18585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AAAAGAGACCATCAAT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en-US" sz="600" cap="all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+4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+1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 +2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AATGGGATA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4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+2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TGC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TGC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A       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+2</a:t>
            </a:r>
            <a:endParaRPr lang="nl-NL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GGGCA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+6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65839" y="223303"/>
            <a:ext cx="23900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Env2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3558283" y="907442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558289" y="999223"/>
            <a:ext cx="0" cy="32004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Rectangle 46"/>
          <p:cNvSpPr/>
          <p:nvPr/>
        </p:nvSpPr>
        <p:spPr>
          <a:xfrm>
            <a:off x="3501857" y="836076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3494370" y="1070658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3509969" y="1954794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3558274" y="1359777"/>
            <a:ext cx="0" cy="32004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3505204" y="1471284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>
            <a:off x="3558674" y="1720585"/>
            <a:ext cx="0" cy="64008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3" name="Right Brace 52"/>
          <p:cNvSpPr/>
          <p:nvPr/>
        </p:nvSpPr>
        <p:spPr>
          <a:xfrm rot="16200000">
            <a:off x="1993373" y="1751474"/>
            <a:ext cx="36000" cy="10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4" name="Right Brace 53"/>
          <p:cNvSpPr/>
          <p:nvPr/>
        </p:nvSpPr>
        <p:spPr>
          <a:xfrm rot="16200000">
            <a:off x="2036236" y="1932444"/>
            <a:ext cx="36000" cy="10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5" name="Right Brace 54"/>
          <p:cNvSpPr/>
          <p:nvPr/>
        </p:nvSpPr>
        <p:spPr>
          <a:xfrm rot="16200000">
            <a:off x="2081674" y="2039413"/>
            <a:ext cx="36000" cy="25603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6" name="TextBox 55"/>
          <p:cNvSpPr txBox="1"/>
          <p:nvPr/>
        </p:nvSpPr>
        <p:spPr>
          <a:xfrm>
            <a:off x="865839" y="3254522"/>
            <a:ext cx="2229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Env2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 </a:t>
            </a:r>
          </a:p>
        </p:txBody>
      </p:sp>
      <p:sp>
        <p:nvSpPr>
          <p:cNvPr id="57" name="Rectangle 56"/>
          <p:cNvSpPr/>
          <p:nvPr/>
        </p:nvSpPr>
        <p:spPr>
          <a:xfrm>
            <a:off x="865839" y="3702655"/>
            <a:ext cx="3042586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AGCAGGAAGCACTAT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AGCGTCAATGACG</a:t>
            </a: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TGGGCGCAGCGTCAATGAC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TGGGCGCAGCGTCAATGAC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TCAATGA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8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TGGGCGCAGCGTCAATGA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+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GG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CGCAGCGTCAATGA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+5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TGGGAGCAGC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GCAGCGTCAATGA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 +7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CGCAGCGTCAATGACG </a:t>
            </a:r>
            <a:r>
              <a:rPr lang="nl-NL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altLang="zh-CN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+1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T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TGGGCGCAGCGTCAATGACG +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    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ACTATGGGCGCAGCGTCAATGACG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    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CTC    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3</a:t>
            </a:r>
            <a:endParaRPr lang="en-US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CCATCC     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6</a:t>
            </a:r>
          </a:p>
          <a:p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GGGG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+6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CTATGGGCGCAGCGTCAATGACG +6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G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GAGCAGCAGGAAG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TGGGCGCAGCGTCAATGACG +6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G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8" name="Right Brace 57"/>
          <p:cNvSpPr/>
          <p:nvPr/>
        </p:nvSpPr>
        <p:spPr>
          <a:xfrm rot="16200000">
            <a:off x="1859483" y="4675708"/>
            <a:ext cx="34289" cy="17621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59" name="Straight Connector 58"/>
          <p:cNvCxnSpPr/>
          <p:nvPr/>
        </p:nvCxnSpPr>
        <p:spPr>
          <a:xfrm>
            <a:off x="3274223" y="3943266"/>
            <a:ext cx="0" cy="13716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3274229" y="4116020"/>
            <a:ext cx="0" cy="14400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1" name="Rectangle 60"/>
          <p:cNvSpPr/>
          <p:nvPr/>
        </p:nvSpPr>
        <p:spPr>
          <a:xfrm>
            <a:off x="3225013" y="3905247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3217526" y="4077916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3228360" y="5028725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>
            <a:off x="3274214" y="4305119"/>
            <a:ext cx="0" cy="347472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5" name="Rectangle 64"/>
          <p:cNvSpPr/>
          <p:nvPr/>
        </p:nvSpPr>
        <p:spPr>
          <a:xfrm>
            <a:off x="3228360" y="4354710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65"/>
          <p:cNvCxnSpPr/>
          <p:nvPr/>
        </p:nvCxnSpPr>
        <p:spPr>
          <a:xfrm>
            <a:off x="3274614" y="4689745"/>
            <a:ext cx="0" cy="9144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7" name="Right Brace 66"/>
          <p:cNvSpPr/>
          <p:nvPr/>
        </p:nvSpPr>
        <p:spPr>
          <a:xfrm rot="16200000">
            <a:off x="1859484" y="4851916"/>
            <a:ext cx="34289" cy="17621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0" name="Right Brace 69"/>
          <p:cNvSpPr/>
          <p:nvPr/>
        </p:nvSpPr>
        <p:spPr>
          <a:xfrm rot="16200000">
            <a:off x="1853969" y="5219613"/>
            <a:ext cx="36000" cy="36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1" name="Right Brace 70"/>
          <p:cNvSpPr/>
          <p:nvPr/>
        </p:nvSpPr>
        <p:spPr>
          <a:xfrm rot="16200000">
            <a:off x="1856572" y="5398873"/>
            <a:ext cx="36000" cy="36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3" name="TextBox 72"/>
          <p:cNvSpPr txBox="1"/>
          <p:nvPr/>
        </p:nvSpPr>
        <p:spPr>
          <a:xfrm>
            <a:off x="695556" y="837437"/>
            <a:ext cx="27764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98971" y="3887900"/>
            <a:ext cx="27764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×</a:t>
            </a: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6" name="Tijdelijke aanduiding voor inhoud 2"/>
          <p:cNvSpPr>
            <a:spLocks noGrp="1"/>
          </p:cNvSpPr>
          <p:nvPr>
            <p:ph idx="1"/>
          </p:nvPr>
        </p:nvSpPr>
        <p:spPr>
          <a:xfrm>
            <a:off x="5012422" y="656881"/>
            <a:ext cx="2673350" cy="2267294"/>
          </a:xfrm>
        </p:spPr>
        <p:txBody>
          <a:bodyPr>
            <a:normAutofit/>
          </a:bodyPr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AAAAGAGACCATCAAT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AT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 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7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10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AG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8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5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6  +5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1 +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AG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4 +1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AT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CACCC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+9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T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nl-NL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GCAAATGTTAAAAGAGACCATC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GC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+5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007428" y="199529"/>
            <a:ext cx="2520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gGag1+gEnv2 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nl-NL" sz="9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nl-NL" sz="9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>
            <a:off x="7348265" y="894516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7348271" y="994246"/>
            <a:ext cx="0" cy="86868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7327630" y="824748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7344097" y="1288735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7326219" y="2395917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/>
          <p:cNvCxnSpPr/>
          <p:nvPr/>
        </p:nvCxnSpPr>
        <p:spPr>
          <a:xfrm>
            <a:off x="7348256" y="2183479"/>
            <a:ext cx="0" cy="59436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7348269" y="1895955"/>
            <a:ext cx="0" cy="25200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5" name="Rectangle 84"/>
          <p:cNvSpPr/>
          <p:nvPr/>
        </p:nvSpPr>
        <p:spPr>
          <a:xfrm>
            <a:off x="7344093" y="1917394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ight Brace 85"/>
          <p:cNvSpPr/>
          <p:nvPr/>
        </p:nvSpPr>
        <p:spPr>
          <a:xfrm rot="16200000">
            <a:off x="6190154" y="2009035"/>
            <a:ext cx="36000" cy="50400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87" name="Right Brace 86"/>
          <p:cNvSpPr/>
          <p:nvPr/>
        </p:nvSpPr>
        <p:spPr>
          <a:xfrm rot="16200000">
            <a:off x="6187954" y="2471610"/>
            <a:ext cx="36000" cy="14400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88" name="Right Brace 87"/>
          <p:cNvSpPr/>
          <p:nvPr/>
        </p:nvSpPr>
        <p:spPr>
          <a:xfrm rot="16200000">
            <a:off x="6194254" y="2564967"/>
            <a:ext cx="36000" cy="32400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89" name="TextBox 88"/>
          <p:cNvSpPr txBox="1"/>
          <p:nvPr/>
        </p:nvSpPr>
        <p:spPr>
          <a:xfrm>
            <a:off x="5012422" y="3355017"/>
            <a:ext cx="24546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gGag1+gEnv2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2  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 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5019793" y="3777783"/>
            <a:ext cx="2203332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AGCAGGAAGCACTAT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</a:t>
            </a: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GCAGCAGGAAG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GCAGCAGGAAGCACT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      GGGAGCAGCAGGAAG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AG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TAT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AGCA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 -9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8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2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T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  +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8  +5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C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8 +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AG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6  +3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AGCACTAT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</a:t>
            </a:r>
          </a:p>
          <a:p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TT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CC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+3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CCT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5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TC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+6 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TCC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+7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GAGCAGCAGGAAGCAC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GC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CGTCAATGACAATGCGTC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0</a:t>
            </a:r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6724466" y="4006502"/>
            <a:ext cx="0" cy="25200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6724472" y="4296732"/>
            <a:ext cx="0" cy="41148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3" name="Rectangle 92"/>
          <p:cNvSpPr/>
          <p:nvPr/>
        </p:nvSpPr>
        <p:spPr>
          <a:xfrm>
            <a:off x="6673546" y="4041509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/>
          <p:cNvSpPr/>
          <p:nvPr/>
        </p:nvSpPr>
        <p:spPr>
          <a:xfrm>
            <a:off x="6674138" y="4400721"/>
            <a:ext cx="49084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da-DK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/>
          <p:cNvSpPr/>
          <p:nvPr/>
        </p:nvSpPr>
        <p:spPr>
          <a:xfrm>
            <a:off x="6662610" y="5352328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6724457" y="5114490"/>
            <a:ext cx="0" cy="6858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6724470" y="4753941"/>
            <a:ext cx="0" cy="32004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683659" y="4807130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ight Brace 98"/>
          <p:cNvSpPr/>
          <p:nvPr/>
        </p:nvSpPr>
        <p:spPr>
          <a:xfrm rot="16200000">
            <a:off x="5923168" y="5019025"/>
            <a:ext cx="36000" cy="36576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00" name="TextBox 99"/>
          <p:cNvSpPr txBox="1"/>
          <p:nvPr/>
        </p:nvSpPr>
        <p:spPr>
          <a:xfrm>
            <a:off x="4838766" y="843901"/>
            <a:ext cx="277640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866644" y="466900"/>
            <a:ext cx="11967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Gag1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006802" y="480398"/>
            <a:ext cx="12135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Gag1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871700" y="3479791"/>
            <a:ext cx="13120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Env2 target 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019793" y="3567750"/>
            <a:ext cx="12546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Env2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2103330" y="572165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110" name="Isosceles Triangle 109"/>
          <p:cNvSpPr/>
          <p:nvPr/>
        </p:nvSpPr>
        <p:spPr>
          <a:xfrm flipH="1" flipV="1">
            <a:off x="2015943" y="640563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111" name="Straight Connector 110"/>
          <p:cNvCxnSpPr/>
          <p:nvPr/>
        </p:nvCxnSpPr>
        <p:spPr>
          <a:xfrm flipV="1">
            <a:off x="2051915" y="877779"/>
            <a:ext cx="0" cy="8229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6254456" y="587016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113" name="Isosceles Triangle 112"/>
          <p:cNvSpPr/>
          <p:nvPr/>
        </p:nvSpPr>
        <p:spPr>
          <a:xfrm flipH="1" flipV="1">
            <a:off x="6162302" y="630014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cxnSp>
        <p:nvCxnSpPr>
          <p:cNvPr id="114" name="Straight Connector 113"/>
          <p:cNvCxnSpPr/>
          <p:nvPr/>
        </p:nvCxnSpPr>
        <p:spPr>
          <a:xfrm flipV="1">
            <a:off x="6210979" y="859293"/>
            <a:ext cx="0" cy="12801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1925291" y="3626027"/>
            <a:ext cx="3511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116" name="Isosceles Triangle 115"/>
          <p:cNvSpPr/>
          <p:nvPr/>
        </p:nvSpPr>
        <p:spPr>
          <a:xfrm flipH="1" flipV="1">
            <a:off x="1833138" y="3665847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cxnSp>
        <p:nvCxnSpPr>
          <p:cNvPr id="117" name="Straight Connector 116"/>
          <p:cNvCxnSpPr/>
          <p:nvPr/>
        </p:nvCxnSpPr>
        <p:spPr>
          <a:xfrm flipV="1">
            <a:off x="1878637" y="3903068"/>
            <a:ext cx="0" cy="82296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 flipV="1">
            <a:off x="5937969" y="3996860"/>
            <a:ext cx="0" cy="10972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5980029" y="3704053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122" name="Isosceles Triangle 121"/>
          <p:cNvSpPr/>
          <p:nvPr/>
        </p:nvSpPr>
        <p:spPr>
          <a:xfrm flipH="1" flipV="1">
            <a:off x="5895022" y="3751020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106" name="TextBox 105"/>
          <p:cNvSpPr txBox="1"/>
          <p:nvPr/>
        </p:nvSpPr>
        <p:spPr>
          <a:xfrm>
            <a:off x="4862578" y="4325288"/>
            <a:ext cx="277640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7" name="Right Brace 106"/>
          <p:cNvSpPr/>
          <p:nvPr/>
        </p:nvSpPr>
        <p:spPr>
          <a:xfrm rot="16200000">
            <a:off x="5918309" y="5341189"/>
            <a:ext cx="45720" cy="822960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75" name="TextBox 74"/>
          <p:cNvSpPr txBox="1"/>
          <p:nvPr/>
        </p:nvSpPr>
        <p:spPr>
          <a:xfrm>
            <a:off x="319839" y="6252411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ctangle 125"/>
          <p:cNvSpPr/>
          <p:nvPr/>
        </p:nvSpPr>
        <p:spPr>
          <a:xfrm>
            <a:off x="2655873" y="1258883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/>
          <p:cNvSpPr/>
          <p:nvPr/>
        </p:nvSpPr>
        <p:spPr>
          <a:xfrm>
            <a:off x="2057384" y="987421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Rectangle 127"/>
          <p:cNvSpPr/>
          <p:nvPr/>
        </p:nvSpPr>
        <p:spPr>
          <a:xfrm>
            <a:off x="6302359" y="1260467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 128"/>
          <p:cNvSpPr/>
          <p:nvPr/>
        </p:nvSpPr>
        <p:spPr>
          <a:xfrm>
            <a:off x="6301565" y="1354130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4737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ijdelijke aanduiding voor inhoud 2"/>
          <p:cNvSpPr txBox="1">
            <a:spLocks/>
          </p:cNvSpPr>
          <p:nvPr/>
        </p:nvSpPr>
        <p:spPr>
          <a:xfrm>
            <a:off x="994216" y="871979"/>
            <a:ext cx="2653860" cy="2198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</a:t>
            </a:r>
            <a:r>
              <a:rPr lang="en-US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AAAAGAGACCATCAAT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CAT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5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TGCAG -3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CAT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5 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4 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5  +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C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 -14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-16 +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 -35 +8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TGC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sz="600" dirty="0"/>
          </a:p>
        </p:txBody>
      </p:sp>
      <p:sp>
        <p:nvSpPr>
          <p:cNvPr id="36" name="TextBox 35"/>
          <p:cNvSpPr txBox="1"/>
          <p:nvPr/>
        </p:nvSpPr>
        <p:spPr>
          <a:xfrm>
            <a:off x="994215" y="455013"/>
            <a:ext cx="2224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TatRev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1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ight Brace 36"/>
          <p:cNvSpPr/>
          <p:nvPr/>
        </p:nvSpPr>
        <p:spPr>
          <a:xfrm rot="16200000">
            <a:off x="2447850" y="2146174"/>
            <a:ext cx="36000" cy="10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38" name="Straight Connector 37"/>
          <p:cNvCxnSpPr/>
          <p:nvPr/>
        </p:nvCxnSpPr>
        <p:spPr>
          <a:xfrm>
            <a:off x="3546046" y="1118650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3483395" y="1056817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3483987" y="1239808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3546037" y="1567824"/>
            <a:ext cx="0" cy="5029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3546050" y="1189809"/>
            <a:ext cx="0" cy="32004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3493508" y="1674795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>
            <a:off x="3546037" y="2111683"/>
            <a:ext cx="0" cy="64008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5" name="Rectangle 44"/>
          <p:cNvSpPr/>
          <p:nvPr/>
        </p:nvSpPr>
        <p:spPr>
          <a:xfrm>
            <a:off x="3493508" y="2313912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ijdelijke aanduiding voor inhoud 2"/>
          <p:cNvSpPr txBox="1">
            <a:spLocks/>
          </p:cNvSpPr>
          <p:nvPr/>
        </p:nvSpPr>
        <p:spPr>
          <a:xfrm>
            <a:off x="983738" y="3650529"/>
            <a:ext cx="3042454" cy="20219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CAGGAAGAAGCGGAG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GAC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nl-NL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-2   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-4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8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-1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GCGGAGACAGCGAC -13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GGAGACAGCGAC -21 +3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AGCGGAGACAGCGAC -15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 -29 +3  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 -28 +2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GGAGACAGCGAC -31 +2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CAGGAAGAAGCGGAGACAGCGAC 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×1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×1 +2 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+2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+2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72014" y="3184369"/>
            <a:ext cx="22903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TatRev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1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 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ight Brace 47"/>
          <p:cNvSpPr/>
          <p:nvPr/>
        </p:nvSpPr>
        <p:spPr>
          <a:xfrm rot="16200000">
            <a:off x="2024000" y="4920761"/>
            <a:ext cx="36000" cy="10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9" name="Rectangle 48"/>
          <p:cNvSpPr/>
          <p:nvPr/>
        </p:nvSpPr>
        <p:spPr>
          <a:xfrm>
            <a:off x="3464052" y="4030917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3526102" y="4451019"/>
            <a:ext cx="0" cy="41148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3526115" y="3907893"/>
            <a:ext cx="0" cy="5029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>
            <a:off x="3473573" y="4554809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>
            <a:off x="3526102" y="4937720"/>
            <a:ext cx="0" cy="5029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4" name="Rectangle 53"/>
          <p:cNvSpPr/>
          <p:nvPr/>
        </p:nvSpPr>
        <p:spPr>
          <a:xfrm>
            <a:off x="3473573" y="5057396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ijdelijke aanduiding voor inhoud 2"/>
          <p:cNvSpPr>
            <a:spLocks noGrp="1"/>
          </p:cNvSpPr>
          <p:nvPr>
            <p:ph idx="1"/>
          </p:nvPr>
        </p:nvSpPr>
        <p:spPr>
          <a:xfrm>
            <a:off x="5081546" y="3564556"/>
            <a:ext cx="2655930" cy="1921705"/>
          </a:xfrm>
        </p:spPr>
        <p:txBody>
          <a:bodyPr>
            <a:normAutofit/>
          </a:bodyPr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CAGGAAGAAGCGGAGA</a:t>
            </a:r>
            <a:r>
              <a:rPr lang="nl-NL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GAC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nl-NL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   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-1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AGAAGCGGAGACAGCGAC -6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AAGAAGCGGAGACAGCGAC -7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AGG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9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</a:t>
            </a:r>
            <a:r>
              <a:rPr lang="nl-NL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13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</a:t>
            </a: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CAGG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  +1    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ACCTTAGGCATC</a:t>
            </a: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  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ACCTT</a:t>
            </a: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nl-NL" sz="6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GGAAGAAGCGGAGACAGCGAC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7 +2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CCTTAGGCATCT</a:t>
            </a:r>
            <a:r>
              <a:rPr lang="nl-NL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CAGGAAGAAGCGGAGACAGCGAC 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nl-NL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nl-NL" sz="6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2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TC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+3 </a:t>
            </a:r>
            <a:endParaRPr lang="en-US" sz="6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1" name="Right Brace 60"/>
          <p:cNvSpPr/>
          <p:nvPr/>
        </p:nvSpPr>
        <p:spPr>
          <a:xfrm rot="16200000">
            <a:off x="6120571" y="4902539"/>
            <a:ext cx="36000" cy="18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0" name="Tijdelijke aanduiding voor inhoud 2"/>
          <p:cNvSpPr txBox="1">
            <a:spLocks/>
          </p:cNvSpPr>
          <p:nvPr/>
        </p:nvSpPr>
        <p:spPr>
          <a:xfrm>
            <a:off x="5094999" y="908070"/>
            <a:ext cx="2570246" cy="16684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ATCAAT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     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AT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 -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 -1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AATGGGAT -17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GGGAT -18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 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54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 -2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CAGAATGGGAT -12 +2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AT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GAT -19 +1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C---------------------</a:t>
            </a:r>
            <a:r>
              <a:rPr lang="en-US" sz="6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 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5 +4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GAT -28 +6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ATGTTAAAAGAGACCATCAATG</a:t>
            </a:r>
            <a:r>
              <a:rPr lang="en-US" sz="6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GCAGAATGGGAT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+1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+3 </a:t>
            </a:r>
            <a:endParaRPr lang="nl-NL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</a:t>
            </a:r>
            <a:r>
              <a:rPr lang="nl-NL" sz="6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CC</a:t>
            </a:r>
            <a:r>
              <a:rPr lang="nl-NL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+4              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059828" y="424747"/>
            <a:ext cx="2431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TatRev</a:t>
            </a:r>
            <a:r>
              <a:rPr lang="nl-NL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2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ight Brace 71"/>
          <p:cNvSpPr/>
          <p:nvPr/>
        </p:nvSpPr>
        <p:spPr>
          <a:xfrm rot="16200000">
            <a:off x="6131875" y="2146224"/>
            <a:ext cx="36000" cy="18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73" name="Straight Connector 72"/>
          <p:cNvCxnSpPr/>
          <p:nvPr/>
        </p:nvCxnSpPr>
        <p:spPr>
          <a:xfrm>
            <a:off x="7623933" y="1161792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4" name="Rectangle 73"/>
          <p:cNvSpPr/>
          <p:nvPr/>
        </p:nvSpPr>
        <p:spPr>
          <a:xfrm>
            <a:off x="7566780" y="1104721"/>
            <a:ext cx="30328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7567372" y="1414719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>
            <a:off x="7623924" y="1798291"/>
            <a:ext cx="0" cy="32004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7623937" y="1248704"/>
            <a:ext cx="0" cy="5029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7576893" y="1821304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/>
          <p:cNvCxnSpPr/>
          <p:nvPr/>
        </p:nvCxnSpPr>
        <p:spPr>
          <a:xfrm>
            <a:off x="7623924" y="2221076"/>
            <a:ext cx="0" cy="2743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7576893" y="2255945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011801" y="666010"/>
            <a:ext cx="11959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Gag1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978976" y="3399389"/>
            <a:ext cx="1319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TatRev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078892" y="649602"/>
            <a:ext cx="1219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Gag1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064939" y="3176661"/>
            <a:ext cx="22903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Gag1+gTatRev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– </a:t>
            </a:r>
            <a:r>
              <a:rPr lang="nl-NL" sz="9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2 </a:t>
            </a:r>
            <a:r>
              <a:rPr lang="nl-NL" sz="9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10</a:t>
            </a:r>
            <a:endParaRPr lang="nl-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071900" y="3415745"/>
            <a:ext cx="1340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gTatRev target </a:t>
            </a:r>
            <a:r>
              <a:rPr lang="nl-NL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767531" y="794055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89" name="Isosceles Triangle 88"/>
          <p:cNvSpPr/>
          <p:nvPr/>
        </p:nvSpPr>
        <p:spPr>
          <a:xfrm flipH="1" flipV="1">
            <a:off x="2654861" y="871979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90" name="Straight Connector 89"/>
          <p:cNvCxnSpPr/>
          <p:nvPr/>
        </p:nvCxnSpPr>
        <p:spPr>
          <a:xfrm flipV="1">
            <a:off x="2468466" y="1069505"/>
            <a:ext cx="0" cy="10972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6197669" y="820793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92" name="Isosceles Triangle 91"/>
          <p:cNvSpPr/>
          <p:nvPr/>
        </p:nvSpPr>
        <p:spPr>
          <a:xfrm flipH="1" flipV="1">
            <a:off x="6104052" y="887832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93" name="Straight Connector 92"/>
          <p:cNvCxnSpPr/>
          <p:nvPr/>
        </p:nvCxnSpPr>
        <p:spPr>
          <a:xfrm flipV="1">
            <a:off x="6151019" y="1104611"/>
            <a:ext cx="0" cy="10972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1665312" y="3568567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95" name="Isosceles Triangle 94"/>
          <p:cNvSpPr/>
          <p:nvPr/>
        </p:nvSpPr>
        <p:spPr>
          <a:xfrm flipH="1" flipV="1">
            <a:off x="1997946" y="3633226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96" name="Straight Connector 95"/>
          <p:cNvCxnSpPr/>
          <p:nvPr/>
        </p:nvCxnSpPr>
        <p:spPr>
          <a:xfrm flipV="1">
            <a:off x="2040151" y="3838097"/>
            <a:ext cx="0" cy="10972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Isosceles Triangle 96"/>
          <p:cNvSpPr/>
          <p:nvPr/>
        </p:nvSpPr>
        <p:spPr>
          <a:xfrm flipH="1" flipV="1">
            <a:off x="6096172" y="3630769"/>
            <a:ext cx="91440" cy="91440"/>
          </a:xfrm>
          <a:prstGeom prst="triangl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cxnSp>
        <p:nvCxnSpPr>
          <p:cNvPr id="98" name="Straight Connector 97"/>
          <p:cNvCxnSpPr/>
          <p:nvPr/>
        </p:nvCxnSpPr>
        <p:spPr>
          <a:xfrm flipV="1">
            <a:off x="6135536" y="3861834"/>
            <a:ext cx="0" cy="109728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5770025" y="3585305"/>
            <a:ext cx="4140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>
                <a:solidFill>
                  <a:srgbClr val="00B0F0"/>
                </a:solidFill>
              </a:rPr>
              <a:t>PAM</a:t>
            </a:r>
            <a:endParaRPr lang="en-US" sz="600" b="1" dirty="0">
              <a:solidFill>
                <a:srgbClr val="00B0F0"/>
              </a:solidFill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937753" y="3836339"/>
            <a:ext cx="277640" cy="12926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836875" y="3870285"/>
            <a:ext cx="277640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871652" y="1235672"/>
            <a:ext cx="27764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</a:lstStyle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×</a:t>
            </a:r>
            <a:endParaRPr lang="en-US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19839" y="6252411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6430156" y="1516054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/>
          <p:cNvSpPr/>
          <p:nvPr/>
        </p:nvSpPr>
        <p:spPr>
          <a:xfrm>
            <a:off x="6429362" y="1697025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/>
          <p:cNvSpPr/>
          <p:nvPr/>
        </p:nvSpPr>
        <p:spPr>
          <a:xfrm>
            <a:off x="6705591" y="1420796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4" name="Straight Connector 113"/>
          <p:cNvCxnSpPr/>
          <p:nvPr/>
        </p:nvCxnSpPr>
        <p:spPr>
          <a:xfrm>
            <a:off x="7620758" y="3908167"/>
            <a:ext cx="0" cy="4572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5" name="Rectangle 114"/>
          <p:cNvSpPr/>
          <p:nvPr/>
        </p:nvSpPr>
        <p:spPr>
          <a:xfrm>
            <a:off x="7563605" y="3851096"/>
            <a:ext cx="588623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bstitu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115"/>
          <p:cNvSpPr/>
          <p:nvPr/>
        </p:nvSpPr>
        <p:spPr>
          <a:xfrm>
            <a:off x="7564197" y="4164269"/>
            <a:ext cx="4700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16"/>
          <p:cNvCxnSpPr/>
          <p:nvPr/>
        </p:nvCxnSpPr>
        <p:spPr>
          <a:xfrm>
            <a:off x="7620749" y="4611341"/>
            <a:ext cx="0" cy="2743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7620762" y="3995079"/>
            <a:ext cx="0" cy="594360"/>
          </a:xfrm>
          <a:prstGeom prst="line">
            <a:avLst/>
          </a:prstGeom>
          <a:ln w="63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9" name="Rectangle 118"/>
          <p:cNvSpPr/>
          <p:nvPr/>
        </p:nvSpPr>
        <p:spPr>
          <a:xfrm>
            <a:off x="7573718" y="4640704"/>
            <a:ext cx="36260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119"/>
          <p:cNvCxnSpPr/>
          <p:nvPr/>
        </p:nvCxnSpPr>
        <p:spPr>
          <a:xfrm>
            <a:off x="7620749" y="4976976"/>
            <a:ext cx="0" cy="2743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1" name="Rectangle 120"/>
          <p:cNvSpPr/>
          <p:nvPr/>
        </p:nvSpPr>
        <p:spPr>
          <a:xfrm>
            <a:off x="7573718" y="5002320"/>
            <a:ext cx="48122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a-DK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Rectangle 121"/>
          <p:cNvSpPr/>
          <p:nvPr/>
        </p:nvSpPr>
        <p:spPr>
          <a:xfrm>
            <a:off x="6277754" y="4080661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ectangle 122"/>
          <p:cNvSpPr/>
          <p:nvPr/>
        </p:nvSpPr>
        <p:spPr>
          <a:xfrm>
            <a:off x="6601604" y="4445786"/>
            <a:ext cx="9144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/>
          <p:cNvSpPr/>
          <p:nvPr/>
        </p:nvSpPr>
        <p:spPr>
          <a:xfrm>
            <a:off x="2046274" y="4249729"/>
            <a:ext cx="137160" cy="64008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60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0</TotalTime>
  <Words>2881</Words>
  <Application>Microsoft Office PowerPoint</Application>
  <PresentationFormat>On-screen Show (4:3)</PresentationFormat>
  <Paragraphs>918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等线</vt:lpstr>
      <vt:lpstr>SimSun</vt:lpstr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Z.</dc:creator>
  <cp:lastModifiedBy>Zongliang Gao</cp:lastModifiedBy>
  <cp:revision>276</cp:revision>
  <cp:lastPrinted>2019-06-25T17:24:57Z</cp:lastPrinted>
  <dcterms:created xsi:type="dcterms:W3CDTF">2019-03-21T17:33:29Z</dcterms:created>
  <dcterms:modified xsi:type="dcterms:W3CDTF">2020-03-17T18:17:51Z</dcterms:modified>
</cp:coreProperties>
</file>